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343"/>
    <a:srgbClr val="BFFF9F"/>
    <a:srgbClr val="D6FFC1"/>
    <a:srgbClr val="99FF66"/>
    <a:srgbClr val="BE7DFF"/>
    <a:srgbClr val="99FF33"/>
    <a:srgbClr val="66FF66"/>
    <a:srgbClr val="057389"/>
    <a:srgbClr val="33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13" autoAdjust="0"/>
    <p:restoredTop sz="96238" autoAdjust="0"/>
  </p:normalViewPr>
  <p:slideViewPr>
    <p:cSldViewPr snapToGrid="0">
      <p:cViewPr>
        <p:scale>
          <a:sx n="100" d="100"/>
          <a:sy n="100" d="100"/>
        </p:scale>
        <p:origin x="2982" y="-1368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C473CA-5278-44F3-B643-4F2004260540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181862-6E2C-4ED3-8CC0-D398DA2ED5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61314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181862-6E2C-4ED3-8CC0-D398DA2ED51F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61681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5630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9177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5470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0775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26756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129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9308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7395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781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0882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7957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8BA68C-D9BF-42F1-AC32-41B2A417AC18}" type="datetimeFigureOut">
              <a:rPr lang="ko-KR" altLang="en-US" smtClean="0"/>
              <a:t>2025-01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19CB6D-24EE-4B43-90E7-A7FD68373F2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5968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그림 87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298" t="61217"/>
          <a:stretch/>
        </p:blipFill>
        <p:spPr>
          <a:xfrm>
            <a:off x="3534706" y="5230424"/>
            <a:ext cx="2798438" cy="126293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</p:pic>
      <p:sp>
        <p:nvSpPr>
          <p:cNvPr id="89" name="TextBox 88"/>
          <p:cNvSpPr txBox="1"/>
          <p:nvPr/>
        </p:nvSpPr>
        <p:spPr>
          <a:xfrm>
            <a:off x="1545915" y="4933101"/>
            <a:ext cx="13955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ale (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-week-old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0" name="그림 89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63044" r="55742"/>
          <a:stretch/>
        </p:blipFill>
        <p:spPr>
          <a:xfrm>
            <a:off x="647959" y="5230424"/>
            <a:ext cx="2736580" cy="1262934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</p:pic>
      <p:sp>
        <p:nvSpPr>
          <p:cNvPr id="91" name="TextBox 90"/>
          <p:cNvSpPr txBox="1"/>
          <p:nvPr/>
        </p:nvSpPr>
        <p:spPr>
          <a:xfrm>
            <a:off x="923301" y="5368139"/>
            <a:ext cx="845440" cy="4996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88" b="1" dirty="0">
                <a:latin typeface="Arial" panose="020B0604020202020204" pitchFamily="34" charset="0"/>
                <a:cs typeface="Arial" panose="020B0604020202020204" pitchFamily="34" charset="0"/>
              </a:rPr>
              <a:t>Wild-type</a:t>
            </a:r>
            <a:endParaRPr lang="ko-KR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직사각형 91"/>
          <p:cNvSpPr/>
          <p:nvPr/>
        </p:nvSpPr>
        <p:spPr>
          <a:xfrm>
            <a:off x="2243706" y="5377819"/>
            <a:ext cx="1006800" cy="3186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788" b="1" i="1" dirty="0">
                <a:latin typeface="Arial" panose="020B0604020202020204" pitchFamily="34" charset="0"/>
                <a:cs typeface="Arial" panose="020B0604020202020204" pitchFamily="34" charset="0"/>
              </a:rPr>
              <a:t>Nrap</a:t>
            </a:r>
            <a:r>
              <a:rPr lang="en-US" altLang="ko-KR" sz="788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c.255ins78</a:t>
            </a:r>
            <a:endParaRPr lang="ko-KR" altLang="en-US" sz="788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3985404" y="5362274"/>
            <a:ext cx="845440" cy="4996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88" b="1" dirty="0">
                <a:latin typeface="Arial" panose="020B0604020202020204" pitchFamily="34" charset="0"/>
                <a:cs typeface="Arial" panose="020B0604020202020204" pitchFamily="34" charset="0"/>
              </a:rPr>
              <a:t>Wild-type</a:t>
            </a:r>
            <a:endParaRPr lang="ko-KR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직사각형 93"/>
          <p:cNvSpPr/>
          <p:nvPr/>
        </p:nvSpPr>
        <p:spPr>
          <a:xfrm>
            <a:off x="5281542" y="5362274"/>
            <a:ext cx="1006800" cy="3186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788" b="1" i="1" dirty="0">
                <a:latin typeface="Arial" panose="020B0604020202020204" pitchFamily="34" charset="0"/>
                <a:cs typeface="Arial" panose="020B0604020202020204" pitchFamily="34" charset="0"/>
              </a:rPr>
              <a:t>Nrap</a:t>
            </a:r>
            <a:r>
              <a:rPr lang="en-US" altLang="ko-KR" sz="788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c.255ins78</a:t>
            </a:r>
            <a:endParaRPr lang="ko-KR" altLang="en-US" sz="788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324304" y="4933101"/>
            <a:ext cx="15619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Female (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-week-old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직선 연결선 97"/>
          <p:cNvCxnSpPr/>
          <p:nvPr/>
        </p:nvCxnSpPr>
        <p:spPr>
          <a:xfrm>
            <a:off x="754834" y="5831817"/>
            <a:ext cx="286603" cy="0"/>
          </a:xfrm>
          <a:prstGeom prst="line">
            <a:avLst/>
          </a:prstGeom>
          <a:ln w="15875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740445" y="5821393"/>
            <a:ext cx="395104" cy="193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50" b="1" dirty="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mm</a:t>
            </a:r>
            <a:endParaRPr lang="ko-KR" altLang="en-US" sz="450" b="1" dirty="0">
              <a:solidFill>
                <a:schemeClr val="accent4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직사각형 99"/>
          <p:cNvSpPr/>
          <p:nvPr/>
        </p:nvSpPr>
        <p:spPr>
          <a:xfrm>
            <a:off x="610670" y="6640753"/>
            <a:ext cx="584807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914400" fontAlgn="base">
              <a:lnSpc>
                <a:spcPct val="200000"/>
              </a:lnSpc>
              <a:defRPr/>
            </a:pP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heart tissue </a:t>
            </a:r>
            <a:r>
              <a:rPr lang="en-US" altLang="ko-K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rap</a:t>
            </a:r>
            <a:r>
              <a:rPr lang="en-US" altLang="ko-KR" sz="11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255ins75</a:t>
            </a:r>
            <a:r>
              <a:rPr lang="en-US" altLang="ko-KR" sz="11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wild-type mice. 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610670" y="2685201"/>
            <a:ext cx="5848071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914400" fontAlgn="base">
              <a:lnSpc>
                <a:spcPct val="200000"/>
              </a:lnSpc>
              <a:defRPr/>
            </a:pP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 of </a:t>
            </a:r>
            <a:r>
              <a:rPr lang="en-US" altLang="ko-KR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b3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ino acid sequences between mouse and camel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tein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 number used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alignment are camel: XP_006174837.1 and mouse: NP_001398710.1. The alignment was performed using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alin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ttp://multalin.toulouse.inra.fr/multalin/).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7959" y="807634"/>
            <a:ext cx="5371842" cy="18775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69904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02</TotalTime>
  <Words>67</Words>
  <Application>Microsoft Office PowerPoint</Application>
  <PresentationFormat>와이드스크린</PresentationFormat>
  <Paragraphs>10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성연</dc:creator>
  <cp:lastModifiedBy>이 성연</cp:lastModifiedBy>
  <cp:revision>232</cp:revision>
  <dcterms:created xsi:type="dcterms:W3CDTF">2024-06-17T09:08:42Z</dcterms:created>
  <dcterms:modified xsi:type="dcterms:W3CDTF">2025-01-31T07:22:50Z</dcterms:modified>
</cp:coreProperties>
</file>